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9" r:id="rId10"/>
    <p:sldId id="272" r:id="rId11"/>
    <p:sldId id="273" r:id="rId12"/>
    <p:sldId id="274" r:id="rId13"/>
    <p:sldId id="268" r:id="rId14"/>
    <p:sldId id="270" r:id="rId15"/>
    <p:sldId id="271" r:id="rId1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63" d="100"/>
          <a:sy n="63" d="100"/>
        </p:scale>
        <p:origin x="-254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heme" Target="theme/theme1.xml"/><Relationship Id="rId21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printerSettings" Target="printerSettings/printerSettings1.bin"/><Relationship Id="rId18" Type="http://schemas.openxmlformats.org/officeDocument/2006/relationships/presProps" Target="presProps.xml"/><Relationship Id="rId1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200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385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64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76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294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52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022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059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2523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00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0140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C0A4D0-BB66-D942-ABD2-163E3CC5D302}" type="datetimeFigureOut">
              <a:rPr lang="en-US" smtClean="0"/>
              <a:t>2/15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F2EA1-CC16-0D40-99D4-2837B8C6F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7696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9.png"/><Relationship Id="rId3" Type="http://schemas.openxmlformats.org/officeDocument/2006/relationships/image" Target="../media/image20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1.png"/><Relationship Id="rId3" Type="http://schemas.openxmlformats.org/officeDocument/2006/relationships/image" Target="../media/image22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3.png"/><Relationship Id="rId3" Type="http://schemas.openxmlformats.org/officeDocument/2006/relationships/image" Target="../media/image24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5.png"/><Relationship Id="rId3" Type="http://schemas.openxmlformats.org/officeDocument/2006/relationships/image" Target="../media/image26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7.png"/><Relationship Id="rId3" Type="http://schemas.openxmlformats.org/officeDocument/2006/relationships/image" Target="../media/image28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Relationship Id="rId3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Relationship Id="rId3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png"/><Relationship Id="rId3" Type="http://schemas.openxmlformats.org/officeDocument/2006/relationships/image" Target="../media/image11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2.png"/><Relationship Id="rId3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6.png"/><Relationship Id="rId3" Type="http://schemas.openxmlformats.org/officeDocument/2006/relationships/image" Target="../media/image1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0004" y="398467"/>
            <a:ext cx="3650512" cy="27378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TextBox 32"/>
          <p:cNvSpPr txBox="1"/>
          <p:nvPr/>
        </p:nvSpPr>
        <p:spPr>
          <a:xfrm>
            <a:off x="1179726" y="261495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90004" y="3136351"/>
            <a:ext cx="3650512" cy="273788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0003" y="6151380"/>
            <a:ext cx="3650841" cy="27381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TextBox 35"/>
          <p:cNvSpPr txBox="1"/>
          <p:nvPr/>
        </p:nvSpPr>
        <p:spPr>
          <a:xfrm>
            <a:off x="1229516" y="608441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49276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3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8985" y="5235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8985" y="4817070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216550982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3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4584" y="647507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4584" y="47741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37556093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3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8818" y="647507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8818" y="4851573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64819990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4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3255" y="5235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3255" y="47741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3432014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4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260" y="47741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260" y="634292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141732151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4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0899" y="634292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34744064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2141" y="630827"/>
            <a:ext cx="5417709" cy="4063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2142" y="4861586"/>
            <a:ext cx="5417708" cy="406328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9984473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 (continued)</a:t>
            </a:r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3488" y="628485"/>
            <a:ext cx="5425439" cy="40690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3488" y="4834623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19586745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8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3789" y="5235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3789" y="47741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10176321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82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24214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dirty="0" smtClean="0"/>
              <a:t>Figure 2 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94229" y="5235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94229" y="4786101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1017632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3603" y="629541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13603" y="47741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10176321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297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290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3444" y="523549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3444" y="4701381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3432014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82184" y="589968"/>
            <a:ext cx="3302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282184" y="4774149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H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74440" y="673001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4440" y="4917852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34320145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Box 32"/>
          <p:cNvSpPr txBox="1"/>
          <p:nvPr/>
        </p:nvSpPr>
        <p:spPr>
          <a:xfrm>
            <a:off x="232394" y="523549"/>
            <a:ext cx="242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I</a:t>
            </a:r>
            <a:endParaRPr lang="en-US" dirty="0"/>
          </a:p>
        </p:txBody>
      </p:sp>
      <p:sp>
        <p:nvSpPr>
          <p:cNvPr id="37" name="TextBox 36"/>
          <p:cNvSpPr txBox="1"/>
          <p:nvPr/>
        </p:nvSpPr>
        <p:spPr>
          <a:xfrm>
            <a:off x="-46802" y="-34377"/>
            <a:ext cx="3561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/>
              <a:t>2</a:t>
            </a:r>
            <a:r>
              <a:rPr lang="en-US" dirty="0" smtClean="0"/>
              <a:t> (continued)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81463" y="669857"/>
            <a:ext cx="5425439" cy="4069079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  <p:extLst>
      <p:ext uri="{BB962C8B-B14F-4D97-AF65-F5344CB8AC3E}">
        <p14:creationId xmlns:p14="http://schemas.microsoft.com/office/powerpoint/2010/main" val="41143595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06</Words>
  <Application>Microsoft Macintosh PowerPoint</Application>
  <PresentationFormat>On-screen Show (4:3)</PresentationFormat>
  <Paragraphs>43</Paragraphs>
  <Slides>1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C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ul Catena</dc:creator>
  <cp:lastModifiedBy>Raul Catena</cp:lastModifiedBy>
  <cp:revision>7</cp:revision>
  <dcterms:created xsi:type="dcterms:W3CDTF">2016-02-15T06:59:53Z</dcterms:created>
  <dcterms:modified xsi:type="dcterms:W3CDTF">2016-02-15T07:33:23Z</dcterms:modified>
</cp:coreProperties>
</file>